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4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2"/>
          <p:cNvSpPr/>
          <p:nvPr/>
        </p:nvSpPr>
        <p:spPr>
          <a:xfrm>
            <a:off x="8990251" y="3515296"/>
            <a:ext cx="210393" cy="914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8730800" y="6484980"/>
            <a:ext cx="244948" cy="2857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68432" y="94797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9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781" y="672401"/>
            <a:ext cx="5354347" cy="4014241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 rot="16200000">
            <a:off x="-1264887" y="2310052"/>
            <a:ext cx="334366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Arial" charset="0"/>
                <a:ea typeface="Arial" charset="0"/>
                <a:cs typeface="Arial" charset="0"/>
              </a:defRPr>
            </a:pPr>
            <a:r>
              <a:rPr lang="en-US" sz="1400" b="1">
                <a:solidFill>
                  <a:sysClr val="windowText" lastClr="000000"/>
                </a:solidFill>
                <a:latin typeface="Arial" charset="0"/>
                <a:ea typeface="Arial" charset="0"/>
                <a:cs typeface="Arial" charset="0"/>
              </a:rPr>
              <a:t>SIINFEKL-MHC Class </a:t>
            </a:r>
            <a:r>
              <a:rPr lang="en-US" sz="1400" b="1" dirty="0">
                <a:solidFill>
                  <a:sysClr val="windowText" lastClr="000000"/>
                </a:solidFill>
                <a:latin typeface="Arial" charset="0"/>
                <a:ea typeface="Arial" charset="0"/>
                <a:cs typeface="Arial" charset="0"/>
              </a:rPr>
              <a:t>I, MFI, %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873102" y="968279"/>
            <a:ext cx="201768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847935" y="1406251"/>
            <a:ext cx="182453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Pharmacologic</a:t>
            </a:r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  <p:sp>
        <p:nvSpPr>
          <p:cNvPr id="14" name="Rectangle 13"/>
          <p:cNvSpPr/>
          <p:nvPr/>
        </p:nvSpPr>
        <p:spPr>
          <a:xfrm rot="16200000">
            <a:off x="2558560" y="998096"/>
            <a:ext cx="274320" cy="274320"/>
          </a:xfrm>
          <a:prstGeom prst="rect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sp>
        <p:nvSpPr>
          <p:cNvPr id="15" name="Rectangle 14"/>
          <p:cNvSpPr/>
          <p:nvPr/>
        </p:nvSpPr>
        <p:spPr>
          <a:xfrm rot="16200000">
            <a:off x="2559692" y="1460950"/>
            <a:ext cx="274320" cy="27432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sp>
        <p:nvSpPr>
          <p:cNvPr id="2" name="Rectangle 1"/>
          <p:cNvSpPr/>
          <p:nvPr/>
        </p:nvSpPr>
        <p:spPr>
          <a:xfrm>
            <a:off x="73448" y="4801048"/>
            <a:ext cx="649501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Fig. S9.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ffect of the top pharmacologics that increased proteasome ChT-like activity on presentation of the SIINFEKL-MHC class I molecule complex. E.G7-Ova cells were treated with pharmacologics at 3 uM for 72 h. Cells were then stained with a monoclonal antibody to Ova 257-264 (SIINFEKL) peptide bound to H2K</a:t>
            </a:r>
            <a:r>
              <a:rPr lang="en-US" sz="1200" baseline="300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nd quantitated using a BD-LSRII sorter interfaced with FlowJo software. 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48008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4</TotalTime>
  <Words>78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100</cp:revision>
  <cp:lastPrinted>2024-03-02T18:31:01Z</cp:lastPrinted>
  <dcterms:created xsi:type="dcterms:W3CDTF">2022-08-15T18:48:13Z</dcterms:created>
  <dcterms:modified xsi:type="dcterms:W3CDTF">2024-05-03T22:05:34Z</dcterms:modified>
</cp:coreProperties>
</file>